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7199313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84"/>
  </p:normalViewPr>
  <p:slideViewPr>
    <p:cSldViewPr snapToGrid="0" snapToObjects="1">
      <p:cViewPr>
        <p:scale>
          <a:sx n="152" d="100"/>
          <a:sy n="152" d="100"/>
        </p:scale>
        <p:origin x="1408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949" y="2356703"/>
            <a:ext cx="6119416" cy="5013407"/>
          </a:xfrm>
        </p:spPr>
        <p:txBody>
          <a:bodyPr anchor="b"/>
          <a:lstStyle>
            <a:lvl1pPr algn="ctr">
              <a:defRPr sz="4724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9914" y="7563446"/>
            <a:ext cx="5399485" cy="3476717"/>
          </a:xfrm>
        </p:spPr>
        <p:txBody>
          <a:bodyPr/>
          <a:lstStyle>
            <a:lvl1pPr marL="0" indent="0" algn="ctr">
              <a:buNone/>
              <a:defRPr sz="1890"/>
            </a:lvl1pPr>
            <a:lvl2pPr marL="359954" indent="0" algn="ctr">
              <a:buNone/>
              <a:defRPr sz="1575"/>
            </a:lvl2pPr>
            <a:lvl3pPr marL="719907" indent="0" algn="ctr">
              <a:buNone/>
              <a:defRPr sz="1417"/>
            </a:lvl3pPr>
            <a:lvl4pPr marL="1079861" indent="0" algn="ctr">
              <a:buNone/>
              <a:defRPr sz="1260"/>
            </a:lvl4pPr>
            <a:lvl5pPr marL="1439814" indent="0" algn="ctr">
              <a:buNone/>
              <a:defRPr sz="1260"/>
            </a:lvl5pPr>
            <a:lvl6pPr marL="1799768" indent="0" algn="ctr">
              <a:buNone/>
              <a:defRPr sz="1260"/>
            </a:lvl6pPr>
            <a:lvl7pPr marL="2159721" indent="0" algn="ctr">
              <a:buNone/>
              <a:defRPr sz="1260"/>
            </a:lvl7pPr>
            <a:lvl8pPr marL="2519675" indent="0" algn="ctr">
              <a:buNone/>
              <a:defRPr sz="1260"/>
            </a:lvl8pPr>
            <a:lvl9pPr marL="2879628" indent="0" algn="ctr">
              <a:buNone/>
              <a:defRPr sz="126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1DE7A-CF9B-0948-8F08-8F9F985649A0}" type="datetimeFigureOut">
              <a:rPr lang="en-ES" smtClean="0"/>
              <a:t>05/11/2020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A4F92-15E1-F948-B263-0DD44CBBD860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36763493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1DE7A-CF9B-0948-8F08-8F9F985649A0}" type="datetimeFigureOut">
              <a:rPr lang="en-ES" smtClean="0"/>
              <a:t>05/11/2020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A4F92-15E1-F948-B263-0DD44CBBD860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2913031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52009" y="766678"/>
            <a:ext cx="1552352" cy="12203515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4953" y="766678"/>
            <a:ext cx="4567064" cy="12203515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1DE7A-CF9B-0948-8F08-8F9F985649A0}" type="datetimeFigureOut">
              <a:rPr lang="en-ES" smtClean="0"/>
              <a:t>05/11/2020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A4F92-15E1-F948-B263-0DD44CBBD860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029439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1DE7A-CF9B-0948-8F08-8F9F985649A0}" type="datetimeFigureOut">
              <a:rPr lang="en-ES" smtClean="0"/>
              <a:t>05/11/2020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A4F92-15E1-F948-B263-0DD44CBBD860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3789541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1204" y="3590057"/>
            <a:ext cx="6209407" cy="5990088"/>
          </a:xfrm>
        </p:spPr>
        <p:txBody>
          <a:bodyPr anchor="b"/>
          <a:lstStyle>
            <a:lvl1pPr>
              <a:defRPr sz="4724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1204" y="9636813"/>
            <a:ext cx="6209407" cy="3150046"/>
          </a:xfrm>
        </p:spPr>
        <p:txBody>
          <a:bodyPr/>
          <a:lstStyle>
            <a:lvl1pPr marL="0" indent="0">
              <a:buNone/>
              <a:defRPr sz="1890">
                <a:solidFill>
                  <a:schemeClr val="tx1"/>
                </a:solidFill>
              </a:defRPr>
            </a:lvl1pPr>
            <a:lvl2pPr marL="35995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2pPr>
            <a:lvl3pPr marL="719907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3pPr>
            <a:lvl4pPr marL="107986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4pPr>
            <a:lvl5pPr marL="1439814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5pPr>
            <a:lvl6pPr marL="179976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6pPr>
            <a:lvl7pPr marL="215972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7pPr>
            <a:lvl8pPr marL="251967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8pPr>
            <a:lvl9pPr marL="287962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1DE7A-CF9B-0948-8F08-8F9F985649A0}" type="datetimeFigureOut">
              <a:rPr lang="en-ES" smtClean="0"/>
              <a:t>05/11/2020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A4F92-15E1-F948-B263-0DD44CBBD860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38844902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4953" y="3833390"/>
            <a:ext cx="3059708" cy="913680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4652" y="3833390"/>
            <a:ext cx="3059708" cy="913680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1DE7A-CF9B-0948-8F08-8F9F985649A0}" type="datetimeFigureOut">
              <a:rPr lang="en-ES" smtClean="0"/>
              <a:t>05/11/2020</a:t>
            </a:fld>
            <a:endParaRPr lang="en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A4F92-15E1-F948-B263-0DD44CBBD860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5624115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766681"/>
            <a:ext cx="6209407" cy="2783376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891" y="3530053"/>
            <a:ext cx="3045646" cy="1730025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891" y="5260078"/>
            <a:ext cx="3045646" cy="773678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4652" y="3530053"/>
            <a:ext cx="3060646" cy="1730025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4652" y="5260078"/>
            <a:ext cx="3060646" cy="773678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1DE7A-CF9B-0948-8F08-8F9F985649A0}" type="datetimeFigureOut">
              <a:rPr lang="en-ES" smtClean="0"/>
              <a:t>05/11/2020</a:t>
            </a:fld>
            <a:endParaRPr lang="en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A4F92-15E1-F948-B263-0DD44CBBD860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3357989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1DE7A-CF9B-0948-8F08-8F9F985649A0}" type="datetimeFigureOut">
              <a:rPr lang="en-ES" smtClean="0"/>
              <a:t>05/11/2020</a:t>
            </a:fld>
            <a:endParaRPr lang="en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A4F92-15E1-F948-B263-0DD44CBBD860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0528805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1DE7A-CF9B-0948-8F08-8F9F985649A0}" type="datetimeFigureOut">
              <a:rPr lang="en-ES" smtClean="0"/>
              <a:t>05/11/2020</a:t>
            </a:fld>
            <a:endParaRPr lang="en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A4F92-15E1-F948-B263-0DD44CBBD860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3678628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960014"/>
            <a:ext cx="2321966" cy="3360050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60646" y="2073367"/>
            <a:ext cx="3644652" cy="10233485"/>
          </a:xfrm>
        </p:spPr>
        <p:txBody>
          <a:bodyPr/>
          <a:lstStyle>
            <a:lvl1pPr>
              <a:defRPr sz="2519"/>
            </a:lvl1pPr>
            <a:lvl2pPr>
              <a:defRPr sz="2204"/>
            </a:lvl2pPr>
            <a:lvl3pPr>
              <a:defRPr sz="1890"/>
            </a:lvl3pPr>
            <a:lvl4pPr>
              <a:defRPr sz="1575"/>
            </a:lvl4pPr>
            <a:lvl5pPr>
              <a:defRPr sz="1575"/>
            </a:lvl5pPr>
            <a:lvl6pPr>
              <a:defRPr sz="1575"/>
            </a:lvl6pPr>
            <a:lvl7pPr>
              <a:defRPr sz="1575"/>
            </a:lvl7pPr>
            <a:lvl8pPr>
              <a:defRPr sz="1575"/>
            </a:lvl8pPr>
            <a:lvl9pPr>
              <a:defRPr sz="1575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4320064"/>
            <a:ext cx="2321966" cy="8003453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1DE7A-CF9B-0948-8F08-8F9F985649A0}" type="datetimeFigureOut">
              <a:rPr lang="en-ES" smtClean="0"/>
              <a:t>05/11/2020</a:t>
            </a:fld>
            <a:endParaRPr lang="en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A4F92-15E1-F948-B263-0DD44CBBD860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34703808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960014"/>
            <a:ext cx="2321966" cy="3360050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60646" y="2073367"/>
            <a:ext cx="3644652" cy="10233485"/>
          </a:xfrm>
        </p:spPr>
        <p:txBody>
          <a:bodyPr anchor="t"/>
          <a:lstStyle>
            <a:lvl1pPr marL="0" indent="0">
              <a:buNone/>
              <a:defRPr sz="2519"/>
            </a:lvl1pPr>
            <a:lvl2pPr marL="359954" indent="0">
              <a:buNone/>
              <a:defRPr sz="2204"/>
            </a:lvl2pPr>
            <a:lvl3pPr marL="719907" indent="0">
              <a:buNone/>
              <a:defRPr sz="1890"/>
            </a:lvl3pPr>
            <a:lvl4pPr marL="1079861" indent="0">
              <a:buNone/>
              <a:defRPr sz="1575"/>
            </a:lvl4pPr>
            <a:lvl5pPr marL="1439814" indent="0">
              <a:buNone/>
              <a:defRPr sz="1575"/>
            </a:lvl5pPr>
            <a:lvl6pPr marL="1799768" indent="0">
              <a:buNone/>
              <a:defRPr sz="1575"/>
            </a:lvl6pPr>
            <a:lvl7pPr marL="2159721" indent="0">
              <a:buNone/>
              <a:defRPr sz="1575"/>
            </a:lvl7pPr>
            <a:lvl8pPr marL="2519675" indent="0">
              <a:buNone/>
              <a:defRPr sz="1575"/>
            </a:lvl8pPr>
            <a:lvl9pPr marL="2879628" indent="0">
              <a:buNone/>
              <a:defRPr sz="1575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4320064"/>
            <a:ext cx="2321966" cy="8003453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1DE7A-CF9B-0948-8F08-8F9F985649A0}" type="datetimeFigureOut">
              <a:rPr lang="en-ES" smtClean="0"/>
              <a:t>05/11/2020</a:t>
            </a:fld>
            <a:endParaRPr lang="en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A4F92-15E1-F948-B263-0DD44CBBD860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0197532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4953" y="766681"/>
            <a:ext cx="6209407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953" y="3833390"/>
            <a:ext cx="6209407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4953" y="13346867"/>
            <a:ext cx="1619845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A1DE7A-CF9B-0948-8F08-8F9F985649A0}" type="datetimeFigureOut">
              <a:rPr lang="en-ES" smtClean="0"/>
              <a:t>05/11/2020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84773" y="13346867"/>
            <a:ext cx="2429768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84515" y="13346867"/>
            <a:ext cx="1619845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7A4F92-15E1-F948-B263-0DD44CBBD860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791597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19907" rtl="0" eaLnBrk="1" latinLnBrk="0" hangingPunct="1">
        <a:lnSpc>
          <a:spcPct val="90000"/>
        </a:lnSpc>
        <a:spcBef>
          <a:spcPct val="0"/>
        </a:spcBef>
        <a:buNone/>
        <a:defRPr sz="346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9977" indent="-179977" algn="l" defTabSz="71990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204" kern="1200">
          <a:solidFill>
            <a:schemeClr val="tx1"/>
          </a:solidFill>
          <a:latin typeface="+mn-lt"/>
          <a:ea typeface="+mn-ea"/>
          <a:cs typeface="+mn-cs"/>
        </a:defRPr>
      </a:lvl1pPr>
      <a:lvl2pPr marL="539930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899884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3pPr>
      <a:lvl4pPr marL="1259837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619791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97974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339698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699652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305960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1pPr>
      <a:lvl2pPr marL="35995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719907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07986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43981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79976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15972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519675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287962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7" Type="http://schemas.openxmlformats.org/officeDocument/2006/relationships/image" Target="../media/image6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sv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phic 4">
            <a:extLst>
              <a:ext uri="{FF2B5EF4-FFF2-40B4-BE49-F238E27FC236}">
                <a16:creationId xmlns:a16="http://schemas.microsoft.com/office/drawing/2014/main" id="{4F343A17-10D6-B04B-B63A-0924F2C2707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425381" y="826711"/>
            <a:ext cx="6348549" cy="3174275"/>
          </a:xfrm>
          <a:prstGeom prst="rect">
            <a:avLst/>
          </a:prstGeom>
        </p:spPr>
      </p:pic>
      <p:pic>
        <p:nvPicPr>
          <p:cNvPr id="7" name="Graphic 6">
            <a:extLst>
              <a:ext uri="{FF2B5EF4-FFF2-40B4-BE49-F238E27FC236}">
                <a16:creationId xmlns:a16="http://schemas.microsoft.com/office/drawing/2014/main" id="{F60288E2-A71F-0842-8699-6AEC254E53C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425381" y="4453937"/>
            <a:ext cx="6348549" cy="3756408"/>
          </a:xfrm>
          <a:prstGeom prst="rect">
            <a:avLst/>
          </a:prstGeom>
        </p:spPr>
      </p:pic>
      <p:pic>
        <p:nvPicPr>
          <p:cNvPr id="9" name="Graphic 8">
            <a:extLst>
              <a:ext uri="{FF2B5EF4-FFF2-40B4-BE49-F238E27FC236}">
                <a16:creationId xmlns:a16="http://schemas.microsoft.com/office/drawing/2014/main" id="{7E682D62-B37E-EC4D-AEAA-96DB5194A2C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425381" y="8663305"/>
            <a:ext cx="6348549" cy="3657555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F467FA20-8B5C-BA45-B1A6-1FC2358A5C06}"/>
              </a:ext>
            </a:extLst>
          </p:cNvPr>
          <p:cNvSpPr txBox="1"/>
          <p:nvPr/>
        </p:nvSpPr>
        <p:spPr>
          <a:xfrm>
            <a:off x="425381" y="62285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dirty="0"/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4C86DBA-5C7C-3248-B4D3-E508A8F43A65}"/>
              </a:ext>
            </a:extLst>
          </p:cNvPr>
          <p:cNvSpPr txBox="1"/>
          <p:nvPr/>
        </p:nvSpPr>
        <p:spPr>
          <a:xfrm>
            <a:off x="425381" y="432411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dirty="0"/>
              <a:t>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8181060-5455-8E42-8310-33C7E2815862}"/>
              </a:ext>
            </a:extLst>
          </p:cNvPr>
          <p:cNvSpPr txBox="1"/>
          <p:nvPr/>
        </p:nvSpPr>
        <p:spPr>
          <a:xfrm>
            <a:off x="439608" y="855815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dirty="0"/>
              <a:t>C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8340734D-BF1F-0A46-B6FE-3B388D7C08CB}"/>
              </a:ext>
            </a:extLst>
          </p:cNvPr>
          <p:cNvSpPr/>
          <p:nvPr/>
        </p:nvSpPr>
        <p:spPr>
          <a:xfrm>
            <a:off x="246476" y="108610"/>
            <a:ext cx="621395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>
                <a:latin typeface="Times New Roman" panose="02020603050405020304" pitchFamily="18" charset="0"/>
                <a:ea typeface="Times New Roman" panose="02020603050405020304" pitchFamily="18" charset="0"/>
              </a:rPr>
              <a:t>Figure S5.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Genome wide density plot genes, MITEs and LTR-retrotransposons according to their High (Q1) or Low (Q4) frequency on the population. </a:t>
            </a:r>
            <a:endParaRPr lang="en-ES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59328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</TotalTime>
  <Words>32</Words>
  <Application>Microsoft Macintosh PowerPoint</Application>
  <PresentationFormat>Custom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úl Castanera Andrés</dc:creator>
  <cp:lastModifiedBy>Raúl Castanera Andrés</cp:lastModifiedBy>
  <cp:revision>4</cp:revision>
  <dcterms:created xsi:type="dcterms:W3CDTF">2020-07-28T12:02:08Z</dcterms:created>
  <dcterms:modified xsi:type="dcterms:W3CDTF">2020-11-05T17:24:27Z</dcterms:modified>
</cp:coreProperties>
</file>